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F12EEE2-0FC1-4391-81F6-BD87B5CDA784}" v="2" dt="2024-11-10T20:23:40.85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91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54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ockalingam, Sriram Ponnambalam" userId="0eabd598-83fe-46e1-bd01-a100427c6929" providerId="ADAL" clId="{8F12EEE2-0FC1-4391-81F6-BD87B5CDA784}"/>
    <pc:docChg chg="modSld">
      <pc:chgData name="Chockalingam, Sriram Ponnambalam" userId="0eabd598-83fe-46e1-bd01-a100427c6929" providerId="ADAL" clId="{8F12EEE2-0FC1-4391-81F6-BD87B5CDA784}" dt="2024-11-10T20:23:40.856" v="1" actId="14826"/>
      <pc:docMkLst>
        <pc:docMk/>
      </pc:docMkLst>
      <pc:sldChg chg="modSp">
        <pc:chgData name="Chockalingam, Sriram Ponnambalam" userId="0eabd598-83fe-46e1-bd01-a100427c6929" providerId="ADAL" clId="{8F12EEE2-0FC1-4391-81F6-BD87B5CDA784}" dt="2024-11-10T20:23:40.856" v="1" actId="14826"/>
        <pc:sldMkLst>
          <pc:docMk/>
          <pc:sldMk cId="3095172976" sldId="260"/>
        </pc:sldMkLst>
        <pc:picChg chg="mod">
          <ac:chgData name="Chockalingam, Sriram Ponnambalam" userId="0eabd598-83fe-46e1-bd01-a100427c6929" providerId="ADAL" clId="{8F12EEE2-0FC1-4391-81F6-BD87B5CDA784}" dt="2024-11-10T20:23:40.856" v="1" actId="14826"/>
          <ac:picMkLst>
            <pc:docMk/>
            <pc:sldMk cId="3095172976" sldId="260"/>
            <ac:picMk id="20" creationId="{12798087-0519-9951-EE7F-0FB49488C306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9A83B6-083E-065C-107A-B5355182909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120DE35-91D6-B6F3-F644-C77AF95F6E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C2F504-7B53-CEB0-CA0D-813C58CEA7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4AD0F2-1CD1-25C5-C2D8-26ACD3D5ED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A84C90-524D-EEAE-9745-E3FB95E60F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4205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6251C3-DDB1-C2EF-29FA-86F28C91FB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F5D2973-F08F-6A4D-13DB-F383C6E54C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E3AE60-C4C3-22DF-CC42-0F574E813F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5F72A5-D3E8-3C83-2B72-6EAA35839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770779-8E18-BE6E-78EA-4B8F290910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618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ECB3F7D-4250-4A77-A804-107803721F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6B10A8-0FCF-11BB-0075-6F512CF865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AD3691-6025-1A7D-F90C-46FA86753F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9FFD83-7CE9-467A-C909-5324F367FA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732208-47FB-45B1-184C-3469F6CD80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4514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58F054-09FF-FBD7-D889-E23A636829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226CBC-CABD-EB27-12C8-B8706FBDFF5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A79279-1AE0-A894-F7ED-BEA88DC0FC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A017E4-3D2C-F124-3635-AF65728EE2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411494-7852-840A-D70B-42B6F5977D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4524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AD39F1-C6AA-BD71-EC8D-F5D31FB333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C8CA57-24BD-A497-CEC1-162CE96A94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887018-A383-C506-07E0-489F42BE03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520CB9-A8E6-8B60-E317-ACB679753C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11C407-5C88-E070-9027-6D4D785733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8649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1E2C0E-5BFE-B1A2-7A4D-7A074BAB22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888033-4C6C-F8BA-E36C-2C5E210CD3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CCD27B-F5DD-7732-FC88-57F11B3845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53EA29-1C67-85C0-66DA-2002A55AD0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287CEB-2A65-DED6-3D19-8C0957573B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FBE716-19C7-74BE-81F0-C9A61FEB14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1624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CA71D7-ABEB-A545-A283-8DD8271D4C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AA7FEB-B295-B313-B3C0-C34CE7A283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68BC3D5-6763-9851-F486-E96AD9B274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F05A0BA-3990-BF92-B409-833A8D9EEA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40E68AE-C11A-47D1-541C-0E6A740690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7E497DB-60F8-8536-E6BA-C1AF06C6A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424AAB7-835B-ADB2-1B04-28D0F55F08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3CC5BA0-2EB8-00AB-1259-5A527C17F5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7451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2A4B51-2AC0-A836-4470-937C595607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294C62F-FEFF-10E5-8045-335E40FA9C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B320175-7F11-2FB7-A9AB-E0B49A64C2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5064D29-AAC2-4346-0AED-1338677B3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1415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9FFD398-62FB-EC93-A2A4-A849B7A67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3F68241-E78B-2853-EBC3-05A0B59DC3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58E42E-1D34-B086-5283-D716F33959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924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F4E714-659D-628A-D264-7F2968F813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5477A6-9416-41FC-29AD-F26534E3FC5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3C67BB-5CBA-D937-5C5C-B55BA868B6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DAD277-5926-1B90-7658-A6D2BF6837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833919-30FF-55AC-0B49-DCC44FBFA8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458F0E-E66A-D34B-245E-102272141A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448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5C5018-5BB5-536E-B0C4-612E018975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8186F04-7752-6760-3B39-C0D9B257EA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ADCDAB-1479-706C-8E9C-A784BC06EC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ACCFD1-D925-CC0D-14F7-D9CDF85134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A2BEE1-E4BF-9183-6FD0-295A321EBE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04A72F-7474-CFB4-FF54-8DDD381C4C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2453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CA9C3F6-E7EE-FC21-A66F-6605CD8592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6AF019-3C79-C179-2D15-5DEEDD5772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826153-0B2E-7C87-2877-B2190CDE8F5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95BA648-E0FB-4891-9FF5-F337F9E134A3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EE42A9-2B1C-1ACB-9543-E1003E8FE1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92D0AA-8888-FEF1-2CB1-445AAB3A25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713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2D247BF7-E23E-FBE4-2847-1D3BB6F9373B}"/>
              </a:ext>
            </a:extLst>
          </p:cNvPr>
          <p:cNvSpPr txBox="1"/>
          <p:nvPr/>
        </p:nvSpPr>
        <p:spPr>
          <a:xfrm>
            <a:off x="549607" y="274215"/>
            <a:ext cx="10508774" cy="646331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Figure S1: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lt"/>
                <a:cs typeface="+mn-lt"/>
              </a:rPr>
              <a:t> UMAP visualizations of  different batches and cell-type clusters from the Arabidopsis datasets 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lt"/>
                <a:cs typeface="+mn-lt"/>
              </a:rPr>
              <a:t>after batch correction and integration with Seurat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, 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Scanorama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, 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FastMNN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 and 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ComBat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. 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highlight>
                <a:srgbClr val="FFFF00"/>
              </a:highlight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12798087-0519-9951-EE7F-0FB49488C30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0" y="1487277"/>
            <a:ext cx="12192000" cy="5370575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336CEE89-C422-A3CB-F4F1-A7424FF28CFA}"/>
              </a:ext>
            </a:extLst>
          </p:cNvPr>
          <p:cNvSpPr txBox="1"/>
          <p:nvPr/>
        </p:nvSpPr>
        <p:spPr>
          <a:xfrm>
            <a:off x="6096000" y="1113144"/>
            <a:ext cx="6096000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Cell-types 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89BFF1F-FBF2-1E65-C1F7-E2AEFCD61971}"/>
              </a:ext>
            </a:extLst>
          </p:cNvPr>
          <p:cNvSpPr txBox="1"/>
          <p:nvPr/>
        </p:nvSpPr>
        <p:spPr>
          <a:xfrm>
            <a:off x="94024" y="1109152"/>
            <a:ext cx="589759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Batches </a:t>
            </a:r>
          </a:p>
        </p:txBody>
      </p:sp>
    </p:spTree>
    <p:extLst>
      <p:ext uri="{BB962C8B-B14F-4D97-AF65-F5344CB8AC3E}">
        <p14:creationId xmlns:p14="http://schemas.microsoft.com/office/powerpoint/2010/main" val="3095172976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</TotalTime>
  <Words>31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1_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luru, Srinivas</dc:creator>
  <cp:lastModifiedBy>Chockalingam, Sriram Ponnambalam</cp:lastModifiedBy>
  <cp:revision>7</cp:revision>
  <dcterms:created xsi:type="dcterms:W3CDTF">2024-11-07T18:07:59Z</dcterms:created>
  <dcterms:modified xsi:type="dcterms:W3CDTF">2024-11-10T20:23:43Z</dcterms:modified>
</cp:coreProperties>
</file>